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7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581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270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90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503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480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463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083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117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518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310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468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836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98C45C-96A6-458F-8D21-8362E0184B48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A9AF4-1274-4888-948E-564B17ECA4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117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7.png"/><Relationship Id="rId5" Type="http://schemas.microsoft.com/office/2007/relationships/hdphoto" Target="../media/hdphoto5.wdp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63516" y="1729897"/>
            <a:ext cx="88841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 DAY			4 DAYS		                1 DAY		            Enlarged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878266" y="1294572"/>
            <a:ext cx="27542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Differentiation Medium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568394" y="2040074"/>
            <a:ext cx="4906882" cy="0"/>
          </a:xfrm>
          <a:prstGeom prst="line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184553" y="1300484"/>
            <a:ext cx="20810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 Growth Medium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568394" y="2119395"/>
            <a:ext cx="2459364" cy="1859574"/>
            <a:chOff x="1921789" y="1982193"/>
            <a:chExt cx="2459364" cy="1859574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  <a14:imgEffect>
                        <a14:brightnessContrast bright="30000" contras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83" t="2733" b="17800"/>
            <a:stretch/>
          </p:blipFill>
          <p:spPr>
            <a:xfrm>
              <a:off x="1921789" y="1982193"/>
              <a:ext cx="2459364" cy="1859574"/>
            </a:xfrm>
            <a:prstGeom prst="rect">
              <a:avLst/>
            </a:prstGeom>
          </p:spPr>
        </p:pic>
        <p:cxnSp>
          <p:nvCxnSpPr>
            <p:cNvPr id="11" name="Straight Connector 10"/>
            <p:cNvCxnSpPr/>
            <p:nvPr/>
          </p:nvCxnSpPr>
          <p:spPr>
            <a:xfrm>
              <a:off x="4106937" y="3754475"/>
              <a:ext cx="175888" cy="79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 11"/>
          <p:cNvGrpSpPr/>
          <p:nvPr/>
        </p:nvGrpSpPr>
        <p:grpSpPr>
          <a:xfrm>
            <a:off x="3121344" y="2119395"/>
            <a:ext cx="2459365" cy="1837457"/>
            <a:chOff x="5134962" y="1994069"/>
            <a:chExt cx="2459365" cy="1837457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colorTemperature colorTemp="4700"/>
                      </a14:imgEffect>
                      <a14:imgEffect>
                        <a14:saturation sat="0"/>
                      </a14:imgEffect>
                      <a14:imgEffect>
                        <a14:brightnessContrast bright="36000" contras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4962" y="1994069"/>
              <a:ext cx="2459365" cy="1837457"/>
            </a:xfrm>
            <a:prstGeom prst="rect">
              <a:avLst/>
            </a:prstGeom>
          </p:spPr>
        </p:pic>
        <p:cxnSp>
          <p:nvCxnSpPr>
            <p:cNvPr id="14" name="Straight Connector 13"/>
            <p:cNvCxnSpPr/>
            <p:nvPr/>
          </p:nvCxnSpPr>
          <p:spPr>
            <a:xfrm>
              <a:off x="7313006" y="3745587"/>
              <a:ext cx="175888" cy="79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oup 14"/>
          <p:cNvGrpSpPr>
            <a:grpSpLocks noChangeAspect="1"/>
          </p:cNvGrpSpPr>
          <p:nvPr/>
        </p:nvGrpSpPr>
        <p:grpSpPr>
          <a:xfrm>
            <a:off x="5665775" y="2105722"/>
            <a:ext cx="2460015" cy="1837944"/>
            <a:chOff x="7718872" y="1995801"/>
            <a:chExt cx="2474166" cy="1848427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saturation sat="0"/>
                      </a14:imgEffect>
                      <a14:imgEffect>
                        <a14:brightnessContrast bright="10000" contrast="1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18872" y="1995801"/>
              <a:ext cx="2474166" cy="1848427"/>
            </a:xfrm>
            <a:prstGeom prst="rect">
              <a:avLst/>
            </a:prstGeom>
          </p:spPr>
        </p:pic>
        <p:cxnSp>
          <p:nvCxnSpPr>
            <p:cNvPr id="17" name="Straight Connector 16"/>
            <p:cNvCxnSpPr/>
            <p:nvPr/>
          </p:nvCxnSpPr>
          <p:spPr>
            <a:xfrm>
              <a:off x="9898893" y="3737652"/>
              <a:ext cx="175888" cy="79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TextBox 17"/>
          <p:cNvSpPr txBox="1"/>
          <p:nvPr/>
        </p:nvSpPr>
        <p:spPr>
          <a:xfrm>
            <a:off x="512920" y="397031"/>
            <a:ext cx="10147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: Images of Mice Mammary Gland Epithelial Cultures Prior and After Differentiation</a:t>
            </a:r>
          </a:p>
        </p:txBody>
      </p:sp>
      <p:pic>
        <p:nvPicPr>
          <p:cNvPr id="19" name="Picture 18"/>
          <p:cNvPicPr>
            <a:picLocks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saturation sat="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872" t="18230" r="18527" b="60659"/>
          <a:stretch/>
        </p:blipFill>
        <p:spPr>
          <a:xfrm>
            <a:off x="8464534" y="2093229"/>
            <a:ext cx="2459736" cy="1837944"/>
          </a:xfrm>
          <a:prstGeom prst="rect">
            <a:avLst/>
          </a:prstGeom>
        </p:spPr>
      </p:pic>
      <p:cxnSp>
        <p:nvCxnSpPr>
          <p:cNvPr id="20" name="Straight Connector 19"/>
          <p:cNvCxnSpPr/>
          <p:nvPr/>
        </p:nvCxnSpPr>
        <p:spPr>
          <a:xfrm>
            <a:off x="5695130" y="2037026"/>
            <a:ext cx="2468880" cy="0"/>
          </a:xfrm>
          <a:prstGeom prst="line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>
            <a:cxnSpLocks noChangeAspect="1"/>
          </p:cNvCxnSpPr>
          <p:nvPr/>
        </p:nvCxnSpPr>
        <p:spPr>
          <a:xfrm flipV="1">
            <a:off x="8105437" y="2103061"/>
            <a:ext cx="358774" cy="365760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>
            <a:cxnSpLocks noChangeAspect="1"/>
          </p:cNvCxnSpPr>
          <p:nvPr/>
        </p:nvCxnSpPr>
        <p:spPr>
          <a:xfrm>
            <a:off x="8105437" y="3537047"/>
            <a:ext cx="365760" cy="384987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9322423" y="3543712"/>
            <a:ext cx="1828800" cy="0"/>
          </a:xfrm>
          <a:prstGeom prst="line">
            <a:avLst/>
          </a:prstGeom>
          <a:ln w="19050">
            <a:solidFill>
              <a:srgbClr val="FF00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10399055" y="3204499"/>
            <a:ext cx="731520" cy="0"/>
          </a:xfrm>
          <a:prstGeom prst="line">
            <a:avLst/>
          </a:prstGeom>
          <a:ln w="19050">
            <a:solidFill>
              <a:srgbClr val="FF00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11054269" y="3017641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ucleu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1073932" y="3358387"/>
            <a:ext cx="12314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pithelial cel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-513581" y="3512275"/>
            <a:ext cx="94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ragmen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/>
          <p:cNvCxnSpPr/>
          <p:nvPr/>
        </p:nvCxnSpPr>
        <p:spPr>
          <a:xfrm>
            <a:off x="386681" y="3666164"/>
            <a:ext cx="731520" cy="0"/>
          </a:xfrm>
          <a:prstGeom prst="line">
            <a:avLst/>
          </a:prstGeom>
          <a:ln w="19050">
            <a:solidFill>
              <a:srgbClr val="FF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512919" y="4090950"/>
            <a:ext cx="1033206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mages of epithelial fragments (day 1) and mammary epithelial cells (day 4)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mages of differentiated MEC and enlarged </a:t>
            </a:r>
          </a:p>
        </p:txBody>
      </p:sp>
    </p:spTree>
    <p:extLst>
      <p:ext uri="{BB962C8B-B14F-4D97-AF65-F5344CB8AC3E}">
        <p14:creationId xmlns:p14="http://schemas.microsoft.com/office/powerpoint/2010/main" val="21698401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64000"/>
                    </a14:imgEffect>
                    <a14:imgEffect>
                      <a14:brightnessContrast bright="34000" contrast="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6196" y="2230362"/>
            <a:ext cx="3741573" cy="280348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64000"/>
                    </a14:imgEffect>
                    <a14:imgEffect>
                      <a14:brightnessContrast bright="34000" contrast="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466" y="2230362"/>
            <a:ext cx="3722038" cy="278884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64000"/>
                    </a14:imgEffect>
                    <a14:imgEffect>
                      <a14:brightnessContrast bright="34000" contrast="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5046" y="2230362"/>
            <a:ext cx="3741575" cy="2803483"/>
          </a:xfrm>
          <a:prstGeom prst="rect">
            <a:avLst/>
          </a:prstGeom>
        </p:spPr>
      </p:pic>
      <p:cxnSp>
        <p:nvCxnSpPr>
          <p:cNvPr id="7" name="Straight Connector 6"/>
          <p:cNvCxnSpPr/>
          <p:nvPr/>
        </p:nvCxnSpPr>
        <p:spPr>
          <a:xfrm>
            <a:off x="3482106" y="4849222"/>
            <a:ext cx="36576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7425221" y="4849222"/>
            <a:ext cx="36576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7476021" y="4863861"/>
            <a:ext cx="36576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1432306" y="4861683"/>
            <a:ext cx="36576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795327" y="469580"/>
            <a:ext cx="107131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2: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firmatory Immunostaining Images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f Mice Mammary Gland Epithelial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ultures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55031" y="1853884"/>
            <a:ext cx="103765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uclei (DAPI) 			     Epithelial Cells (Actin)		             Merged (DAPI/Actin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36340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46000"/>
                    </a14:imgEffect>
                    <a14:imgEffect>
                      <a14:brightnessContrast bright="-4000" contrast="-16000"/>
                    </a14:imgEffect>
                  </a14:imgLayer>
                </a14:imgProps>
              </a:ext>
            </a:extLst>
          </a:blip>
          <a:srcRect l="51263"/>
          <a:stretch/>
        </p:blipFill>
        <p:spPr>
          <a:xfrm>
            <a:off x="2433627" y="1173987"/>
            <a:ext cx="7052282" cy="526180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14658" y="399861"/>
            <a:ext cx="10897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3: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onfirmatory Immunostaining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Image </a:t>
            </a:r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of MEC </a:t>
            </a:r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Milk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ipid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Globule</a:t>
            </a:r>
            <a:endParaRPr lang="en-US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5943232" y="3480689"/>
            <a:ext cx="3840480" cy="0"/>
          </a:xfrm>
          <a:prstGeom prst="line">
            <a:avLst/>
          </a:prstGeom>
          <a:ln w="19050">
            <a:solidFill>
              <a:srgbClr val="FF00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8901078" y="2671099"/>
            <a:ext cx="731520" cy="0"/>
          </a:xfrm>
          <a:prstGeom prst="line">
            <a:avLst/>
          </a:prstGeom>
          <a:ln w="19050">
            <a:solidFill>
              <a:srgbClr val="FF00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9632598" y="2517210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ucleus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783712" y="3311412"/>
            <a:ext cx="12650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lk globul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8106557" y="5408869"/>
            <a:ext cx="1828800" cy="0"/>
          </a:xfrm>
          <a:prstGeom prst="line">
            <a:avLst/>
          </a:prstGeom>
          <a:ln w="19050">
            <a:solidFill>
              <a:srgbClr val="FF00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9935357" y="5239592"/>
            <a:ext cx="13773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pithelial cell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1838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>
          <a:solidFill>
            <a:schemeClr val="tx1"/>
          </a:solidFill>
          <a:headEnd type="triangle" w="med" len="med"/>
          <a:tailEnd type="triangle" w="med" len="med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09DE9C1094700468D0F47C9A7155319" ma:contentTypeVersion="10" ma:contentTypeDescription="Create a new document." ma:contentTypeScope="" ma:versionID="edf48eb2d9d49ca01e4a4500bfe1fa47">
  <xsd:schema xmlns:xsd="http://www.w3.org/2001/XMLSchema" xmlns:xs="http://www.w3.org/2001/XMLSchema" xmlns:p="http://schemas.microsoft.com/office/2006/metadata/properties" xmlns:ns3="46513d93-d1ff-4aff-9586-b84c31d4a8ce" targetNamespace="http://schemas.microsoft.com/office/2006/metadata/properties" ma:root="true" ma:fieldsID="456ed82b78482cce2b3bf5f505a15a59" ns3:_="">
    <xsd:import namespace="46513d93-d1ff-4aff-9586-b84c31d4a8c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6513d93-d1ff-4aff-9586-b84c31d4a8c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772020C-7A4F-4237-A891-CB13C855E4B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6513d93-d1ff-4aff-9586-b84c31d4a8c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E1F2C92-4FA1-4E53-97F2-68396C8FC99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145BDA0-B7B5-4AA7-AAEC-8B887BC178B6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46513d93-d1ff-4aff-9586-b84c31d4a8ce"/>
    <ds:schemaRef ds:uri="http://schemas.microsoft.com/office/2006/documentManagement/types"/>
    <ds:schemaRef ds:uri="http://schemas.openxmlformats.org/package/2006/metadata/core-properties"/>
    <ds:schemaRef ds:uri="http://purl.org/dc/dcmitype/"/>
    <ds:schemaRef ds:uri="http://www.w3.org/XML/1998/namespace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9</TotalTime>
  <Words>120</Words>
  <Application>Microsoft Office PowerPoint</Application>
  <PresentationFormat>Widescreen</PresentationFormat>
  <Paragraphs>1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LA BioMedical Research Institute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sai, Mina</dc:creator>
  <cp:lastModifiedBy>Desai, Mina</cp:lastModifiedBy>
  <cp:revision>14</cp:revision>
  <dcterms:created xsi:type="dcterms:W3CDTF">2022-11-10T23:26:18Z</dcterms:created>
  <dcterms:modified xsi:type="dcterms:W3CDTF">2022-11-21T16:53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09DE9C1094700468D0F47C9A7155319</vt:lpwstr>
  </property>
</Properties>
</file>